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11" d="100"/>
          <a:sy n="111" d="100"/>
        </p:scale>
        <p:origin x="-1710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4EB5FB0-CD54-4656-A131-94C0404D0589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A4C78E2-341D-4784-A0CB-BDD62A937CF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400323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968D391-82FA-4D3C-9B6D-3E992B7EE6F7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664919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A9B38A-2D36-4E70-AE57-DAF86E6C9D79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93F0B-7C5B-4F54-AF55-8A57357B98C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503239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A9B38A-2D36-4E70-AE57-DAF86E6C9D79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93F0B-7C5B-4F54-AF55-8A57357B98C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334363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A9B38A-2D36-4E70-AE57-DAF86E6C9D79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93F0B-7C5B-4F54-AF55-8A57357B98C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706635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A9B38A-2D36-4E70-AE57-DAF86E6C9D79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93F0B-7C5B-4F54-AF55-8A57357B98C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690159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A9B38A-2D36-4E70-AE57-DAF86E6C9D79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93F0B-7C5B-4F54-AF55-8A57357B98C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675512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A9B38A-2D36-4E70-AE57-DAF86E6C9D79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93F0B-7C5B-4F54-AF55-8A57357B98C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234478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A9B38A-2D36-4E70-AE57-DAF86E6C9D79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93F0B-7C5B-4F54-AF55-8A57357B98C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983241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A9B38A-2D36-4E70-AE57-DAF86E6C9D79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93F0B-7C5B-4F54-AF55-8A57357B98C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720799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A9B38A-2D36-4E70-AE57-DAF86E6C9D79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93F0B-7C5B-4F54-AF55-8A57357B98C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282798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A9B38A-2D36-4E70-AE57-DAF86E6C9D79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93F0B-7C5B-4F54-AF55-8A57357B98C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669507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A9B38A-2D36-4E70-AE57-DAF86E6C9D79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93F0B-7C5B-4F54-AF55-8A57357B98C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241386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A9B38A-2D36-4E70-AE57-DAF86E6C9D79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793F0B-7C5B-4F54-AF55-8A57357B98C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503487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/>
          <p:cNvGrpSpPr/>
          <p:nvPr/>
        </p:nvGrpSpPr>
        <p:grpSpPr>
          <a:xfrm>
            <a:off x="755576" y="1127823"/>
            <a:ext cx="6182225" cy="4169207"/>
            <a:chOff x="755576" y="1127823"/>
            <a:chExt cx="6182225" cy="4169207"/>
          </a:xfrm>
        </p:grpSpPr>
        <p:pic>
          <p:nvPicPr>
            <p:cNvPr id="188" name="Grafik 187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55576" y="1127824"/>
              <a:ext cx="6182225" cy="3528392"/>
            </a:xfrm>
            <a:prstGeom prst="rect">
              <a:avLst/>
            </a:prstGeom>
          </p:spPr>
        </p:pic>
        <p:sp>
          <p:nvSpPr>
            <p:cNvPr id="190" name="Rechteck 189"/>
            <p:cNvSpPr/>
            <p:nvPr/>
          </p:nvSpPr>
          <p:spPr>
            <a:xfrm>
              <a:off x="1026276" y="4512200"/>
              <a:ext cx="4572000" cy="784830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 lvl="0">
                <a:lnSpc>
                  <a:spcPct val="150000"/>
                </a:lnSpc>
              </a:pPr>
              <a:r>
                <a:rPr lang="de-DE" sz="1000" b="1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3 Fig. </a:t>
              </a:r>
              <a:r>
                <a:rPr lang="de-DE" sz="1000" b="1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ymograms</a:t>
              </a:r>
              <a:r>
                <a:rPr lang="de-DE" sz="1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000" b="1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f</a:t>
              </a:r>
              <a:r>
                <a:rPr lang="de-DE" sz="1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all </a:t>
              </a:r>
              <a:r>
                <a:rPr lang="de-DE" sz="1000" b="1" dirty="0" err="1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era</a:t>
              </a:r>
              <a:r>
                <a:rPr lang="de-DE" sz="1000" b="1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000" b="1" dirty="0" err="1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ested</a:t>
              </a:r>
              <a:r>
                <a:rPr lang="de-DE" sz="1000" b="1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 </a:t>
              </a:r>
              <a:r>
                <a:rPr lang="de-DE" sz="1000" b="1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his</a:t>
              </a:r>
              <a:r>
                <a:rPr lang="de-DE" sz="1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000" b="1" dirty="0" err="1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tudy</a:t>
              </a:r>
              <a:endParaRPr lang="de-DE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lvl="0">
                <a:lnSpc>
                  <a:spcPct val="150000"/>
                </a:lnSpc>
              </a:pPr>
              <a:r>
                <a:rPr lang="de-DE" sz="1000" b="1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:</a:t>
              </a:r>
              <a:r>
                <a:rPr lang="de-DE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000" dirty="0" err="1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era</a:t>
              </a:r>
              <a:r>
                <a:rPr lang="de-DE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000" dirty="0" err="1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rom</a:t>
              </a:r>
              <a:r>
                <a:rPr lang="de-DE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000" dirty="0" err="1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ealthy</a:t>
              </a:r>
              <a:r>
                <a:rPr lang="de-DE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000" dirty="0" err="1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trols</a:t>
              </a:r>
              <a:endPara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lvl="0">
                <a:lnSpc>
                  <a:spcPct val="150000"/>
                </a:lnSpc>
              </a:pPr>
              <a:r>
                <a:rPr lang="de-DE" sz="1000" b="1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: </a:t>
              </a:r>
              <a:r>
                <a:rPr lang="de-DE" sz="1000" dirty="0" err="1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era</a:t>
              </a:r>
              <a:r>
                <a:rPr lang="de-DE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000" dirty="0" err="1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rom</a:t>
              </a:r>
              <a:r>
                <a:rPr lang="de-DE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000" dirty="0" err="1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atients</a:t>
              </a:r>
              <a:r>
                <a:rPr lang="de-DE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000" dirty="0" err="1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ith</a:t>
              </a:r>
              <a:r>
                <a:rPr lang="de-DE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000" dirty="0" err="1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scending</a:t>
              </a:r>
              <a:r>
                <a:rPr lang="de-DE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000" dirty="0" err="1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ortic</a:t>
              </a:r>
              <a:r>
                <a:rPr lang="de-DE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000" dirty="0" err="1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neurysms</a:t>
              </a:r>
              <a:endParaRPr lang="de-DE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1" name="Textfeld 190"/>
            <p:cNvSpPr txBox="1"/>
            <p:nvPr/>
          </p:nvSpPr>
          <p:spPr>
            <a:xfrm>
              <a:off x="887456" y="1127824"/>
              <a:ext cx="277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93" name="Rechteck 192"/>
            <p:cNvSpPr/>
            <p:nvPr/>
          </p:nvSpPr>
          <p:spPr>
            <a:xfrm>
              <a:off x="4122620" y="1127823"/>
              <a:ext cx="27764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de-DE" sz="1000" b="1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de-DE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543107312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9</Words>
  <Application>Microsoft Office PowerPoint</Application>
  <PresentationFormat>Bildschirmpräsentation (4:3)</PresentationFormat>
  <Paragraphs>6</Paragraphs>
  <Slides>1</Slides>
  <Notes>1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Uniklinikum Freibur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r. Anke Tscheuschler</dc:creator>
  <cp:lastModifiedBy>Dr. Anke Tscheuschler</cp:lastModifiedBy>
  <cp:revision>1</cp:revision>
  <dcterms:created xsi:type="dcterms:W3CDTF">2016-09-29T14:06:43Z</dcterms:created>
  <dcterms:modified xsi:type="dcterms:W3CDTF">2016-09-29T14:07:14Z</dcterms:modified>
</cp:coreProperties>
</file>